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993933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7294" autoAdjust="0"/>
    <p:restoredTop sz="61835" autoAdjust="0"/>
  </p:normalViewPr>
  <p:slideViewPr>
    <p:cSldViewPr snapToGrid="0">
      <p:cViewPr varScale="1">
        <p:scale>
          <a:sx n="50" d="100"/>
          <a:sy n="50" d="100"/>
        </p:scale>
        <p:origin x="2309" y="3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2" d="100"/>
          <a:sy n="82" d="100"/>
        </p:scale>
        <p:origin x="2002" y="5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原　悠" userId="5ca70933-9236-41ae-b51f-a8548861fb70" providerId="ADAL" clId="{BAC3A7DB-0E68-415F-94B2-8D342A7FAA6E}"/>
    <pc:docChg chg="delSld">
      <pc:chgData name="原　悠" userId="5ca70933-9236-41ae-b51f-a8548861fb70" providerId="ADAL" clId="{BAC3A7DB-0E68-415F-94B2-8D342A7FAA6E}" dt="2023-08-06T06:07:36.831" v="1" actId="47"/>
      <pc:docMkLst>
        <pc:docMk/>
      </pc:docMkLst>
      <pc:sldChg chg="del">
        <pc:chgData name="原　悠" userId="5ca70933-9236-41ae-b51f-a8548861fb70" providerId="ADAL" clId="{BAC3A7DB-0E68-415F-94B2-8D342A7FAA6E}" dt="2023-08-06T06:07:34.066" v="0" actId="47"/>
        <pc:sldMkLst>
          <pc:docMk/>
          <pc:sldMk cId="591882563" sldId="256"/>
        </pc:sldMkLst>
      </pc:sldChg>
      <pc:sldChg chg="del">
        <pc:chgData name="原　悠" userId="5ca70933-9236-41ae-b51f-a8548861fb70" providerId="ADAL" clId="{BAC3A7DB-0E68-415F-94B2-8D342A7FAA6E}" dt="2023-08-06T06:07:34.066" v="0" actId="47"/>
        <pc:sldMkLst>
          <pc:docMk/>
          <pc:sldMk cId="3505921917" sldId="257"/>
        </pc:sldMkLst>
      </pc:sldChg>
      <pc:sldChg chg="del">
        <pc:chgData name="原　悠" userId="5ca70933-9236-41ae-b51f-a8548861fb70" providerId="ADAL" clId="{BAC3A7DB-0E68-415F-94B2-8D342A7FAA6E}" dt="2023-08-06T06:07:34.066" v="0" actId="47"/>
        <pc:sldMkLst>
          <pc:docMk/>
          <pc:sldMk cId="2023262087" sldId="259"/>
        </pc:sldMkLst>
      </pc:sldChg>
      <pc:sldChg chg="del">
        <pc:chgData name="原　悠" userId="5ca70933-9236-41ae-b51f-a8548861fb70" providerId="ADAL" clId="{BAC3A7DB-0E68-415F-94B2-8D342A7FAA6E}" dt="2023-08-06T06:07:34.066" v="0" actId="47"/>
        <pc:sldMkLst>
          <pc:docMk/>
          <pc:sldMk cId="2163035067" sldId="260"/>
        </pc:sldMkLst>
      </pc:sldChg>
      <pc:sldChg chg="del">
        <pc:chgData name="原　悠" userId="5ca70933-9236-41ae-b51f-a8548861fb70" providerId="ADAL" clId="{BAC3A7DB-0E68-415F-94B2-8D342A7FAA6E}" dt="2023-08-06T06:07:34.066" v="0" actId="47"/>
        <pc:sldMkLst>
          <pc:docMk/>
          <pc:sldMk cId="1157327301" sldId="262"/>
        </pc:sldMkLst>
      </pc:sldChg>
      <pc:sldChg chg="del">
        <pc:chgData name="原　悠" userId="5ca70933-9236-41ae-b51f-a8548861fb70" providerId="ADAL" clId="{BAC3A7DB-0E68-415F-94B2-8D342A7FAA6E}" dt="2023-08-06T06:07:34.066" v="0" actId="47"/>
        <pc:sldMkLst>
          <pc:docMk/>
          <pc:sldMk cId="3647937715" sldId="274"/>
        </pc:sldMkLst>
      </pc:sldChg>
      <pc:sldChg chg="del">
        <pc:chgData name="原　悠" userId="5ca70933-9236-41ae-b51f-a8548861fb70" providerId="ADAL" clId="{BAC3A7DB-0E68-415F-94B2-8D342A7FAA6E}" dt="2023-08-06T06:07:34.066" v="0" actId="47"/>
        <pc:sldMkLst>
          <pc:docMk/>
          <pc:sldMk cId="3904947510" sldId="275"/>
        </pc:sldMkLst>
      </pc:sldChg>
      <pc:sldChg chg="del">
        <pc:chgData name="原　悠" userId="5ca70933-9236-41ae-b51f-a8548861fb70" providerId="ADAL" clId="{BAC3A7DB-0E68-415F-94B2-8D342A7FAA6E}" dt="2023-08-06T06:07:34.066" v="0" actId="47"/>
        <pc:sldMkLst>
          <pc:docMk/>
          <pc:sldMk cId="1982311355" sldId="276"/>
        </pc:sldMkLst>
      </pc:sldChg>
      <pc:sldChg chg="del">
        <pc:chgData name="原　悠" userId="5ca70933-9236-41ae-b51f-a8548861fb70" providerId="ADAL" clId="{BAC3A7DB-0E68-415F-94B2-8D342A7FAA6E}" dt="2023-08-06T06:07:34.066" v="0" actId="47"/>
        <pc:sldMkLst>
          <pc:docMk/>
          <pc:sldMk cId="1905507674" sldId="277"/>
        </pc:sldMkLst>
      </pc:sldChg>
      <pc:sldChg chg="del">
        <pc:chgData name="原　悠" userId="5ca70933-9236-41ae-b51f-a8548861fb70" providerId="ADAL" clId="{BAC3A7DB-0E68-415F-94B2-8D342A7FAA6E}" dt="2023-08-06T06:07:34.066" v="0" actId="47"/>
        <pc:sldMkLst>
          <pc:docMk/>
          <pc:sldMk cId="3405513179" sldId="278"/>
        </pc:sldMkLst>
      </pc:sldChg>
      <pc:sldChg chg="del">
        <pc:chgData name="原　悠" userId="5ca70933-9236-41ae-b51f-a8548861fb70" providerId="ADAL" clId="{BAC3A7DB-0E68-415F-94B2-8D342A7FAA6E}" dt="2023-08-06T06:07:36.831" v="1" actId="47"/>
        <pc:sldMkLst>
          <pc:docMk/>
          <pc:sldMk cId="645788852" sldId="279"/>
        </pc:sldMkLst>
      </pc:sldChg>
    </pc:docChg>
  </pc:docChgLst>
  <pc:docChgLst>
    <pc:chgData name="原　悠" userId="5ca70933-9236-41ae-b51f-a8548861fb70" providerId="ADAL" clId="{AF46780B-1511-4A3E-A647-F33B33846E2B}"/>
    <pc:docChg chg="modSld sldOrd">
      <pc:chgData name="原　悠" userId="5ca70933-9236-41ae-b51f-a8548861fb70" providerId="ADAL" clId="{AF46780B-1511-4A3E-A647-F33B33846E2B}" dt="2023-08-06T04:55:57.273" v="246" actId="13926"/>
      <pc:docMkLst>
        <pc:docMk/>
      </pc:docMkLst>
      <pc:sldChg chg="modSp mod modNotesTx">
        <pc:chgData name="原　悠" userId="5ca70933-9236-41ae-b51f-a8548861fb70" providerId="ADAL" clId="{AF46780B-1511-4A3E-A647-F33B33846E2B}" dt="2023-08-06T03:30:23.266" v="213" actId="13926"/>
        <pc:sldMkLst>
          <pc:docMk/>
          <pc:sldMk cId="3752763700" sldId="258"/>
        </pc:sldMkLst>
        <pc:spChg chg="mod">
          <ac:chgData name="原　悠" userId="5ca70933-9236-41ae-b51f-a8548861fb70" providerId="ADAL" clId="{AF46780B-1511-4A3E-A647-F33B33846E2B}" dt="2023-08-06T03:30:23.266" v="213" actId="13926"/>
          <ac:spMkLst>
            <pc:docMk/>
            <pc:sldMk cId="3752763700" sldId="258"/>
            <ac:spMk id="9" creationId="{67B277C3-A2B8-C76D-EF95-392E1C682D32}"/>
          </ac:spMkLst>
        </pc:spChg>
      </pc:sldChg>
      <pc:sldChg chg="modSp mod modNotesTx">
        <pc:chgData name="原　悠" userId="5ca70933-9236-41ae-b51f-a8548861fb70" providerId="ADAL" clId="{AF46780B-1511-4A3E-A647-F33B33846E2B}" dt="2023-08-06T04:55:57.273" v="246" actId="13926"/>
        <pc:sldMkLst>
          <pc:docMk/>
          <pc:sldMk cId="2023262087" sldId="259"/>
        </pc:sldMkLst>
        <pc:spChg chg="mod">
          <ac:chgData name="原　悠" userId="5ca70933-9236-41ae-b51f-a8548861fb70" providerId="ADAL" clId="{AF46780B-1511-4A3E-A647-F33B33846E2B}" dt="2023-08-06T03:22:34.216" v="188" actId="554"/>
          <ac:spMkLst>
            <pc:docMk/>
            <pc:sldMk cId="2023262087" sldId="259"/>
            <ac:spMk id="3" creationId="{DA3FD359-D048-C3A4-351F-39DEFDA7C99D}"/>
          </ac:spMkLst>
        </pc:spChg>
        <pc:graphicFrameChg chg="mod modGraphic">
          <ac:chgData name="原　悠" userId="5ca70933-9236-41ae-b51f-a8548861fb70" providerId="ADAL" clId="{AF46780B-1511-4A3E-A647-F33B33846E2B}" dt="2023-08-06T03:22:46.536" v="202" actId="555"/>
          <ac:graphicFrameMkLst>
            <pc:docMk/>
            <pc:sldMk cId="2023262087" sldId="259"/>
            <ac:graphicFrameMk id="2" creationId="{091E4CBE-773D-4CA0-B1AF-D12C41AC2F0D}"/>
          </ac:graphicFrameMkLst>
        </pc:graphicFrameChg>
      </pc:sldChg>
      <pc:sldChg chg="modSp mod">
        <pc:chgData name="原　悠" userId="5ca70933-9236-41ae-b51f-a8548861fb70" providerId="ADAL" clId="{AF46780B-1511-4A3E-A647-F33B33846E2B}" dt="2023-08-06T03:28:55.256" v="203" actId="13926"/>
        <pc:sldMkLst>
          <pc:docMk/>
          <pc:sldMk cId="1157327301" sldId="262"/>
        </pc:sldMkLst>
        <pc:graphicFrameChg chg="modGraphic">
          <ac:chgData name="原　悠" userId="5ca70933-9236-41ae-b51f-a8548861fb70" providerId="ADAL" clId="{AF46780B-1511-4A3E-A647-F33B33846E2B}" dt="2023-08-06T03:28:55.256" v="203" actId="13926"/>
          <ac:graphicFrameMkLst>
            <pc:docMk/>
            <pc:sldMk cId="1157327301" sldId="262"/>
            <ac:graphicFrameMk id="5" creationId="{48E08C8B-2E64-DBD8-8590-9662866AFEBD}"/>
          </ac:graphicFrameMkLst>
        </pc:graphicFrameChg>
      </pc:sldChg>
      <pc:sldChg chg="modSp mod ord modNotesTx">
        <pc:chgData name="原　悠" userId="5ca70933-9236-41ae-b51f-a8548861fb70" providerId="ADAL" clId="{AF46780B-1511-4A3E-A647-F33B33846E2B}" dt="2023-08-06T00:48:02.483" v="17" actId="20577"/>
        <pc:sldMkLst>
          <pc:docMk/>
          <pc:sldMk cId="3647937715" sldId="274"/>
        </pc:sldMkLst>
        <pc:spChg chg="mod">
          <ac:chgData name="原　悠" userId="5ca70933-9236-41ae-b51f-a8548861fb70" providerId="ADAL" clId="{AF46780B-1511-4A3E-A647-F33B33846E2B}" dt="2023-08-06T00:47:35.389" v="5" actId="20577"/>
          <ac:spMkLst>
            <pc:docMk/>
            <pc:sldMk cId="3647937715" sldId="274"/>
            <ac:spMk id="5" creationId="{729D6172-477D-C897-A41F-8A8646FC811C}"/>
          </ac:spMkLst>
        </pc:spChg>
      </pc:sldChg>
      <pc:sldChg chg="modSp mod">
        <pc:chgData name="原　悠" userId="5ca70933-9236-41ae-b51f-a8548861fb70" providerId="ADAL" clId="{AF46780B-1511-4A3E-A647-F33B33846E2B}" dt="2023-08-06T03:29:59.785" v="210" actId="12789"/>
        <pc:sldMkLst>
          <pc:docMk/>
          <pc:sldMk cId="1982311355" sldId="276"/>
        </pc:sldMkLst>
        <pc:graphicFrameChg chg="mod modGraphic">
          <ac:chgData name="原　悠" userId="5ca70933-9236-41ae-b51f-a8548861fb70" providerId="ADAL" clId="{AF46780B-1511-4A3E-A647-F33B33846E2B}" dt="2023-08-06T03:29:59.785" v="210" actId="12789"/>
          <ac:graphicFrameMkLst>
            <pc:docMk/>
            <pc:sldMk cId="1982311355" sldId="276"/>
            <ac:graphicFrameMk id="2" creationId="{091E4CBE-773D-4CA0-B1AF-D12C41AC2F0D}"/>
          </ac:graphicFrameMkLst>
        </pc:graphicFrameChg>
      </pc:sldChg>
      <pc:sldChg chg="modSp mod">
        <pc:chgData name="原　悠" userId="5ca70933-9236-41ae-b51f-a8548861fb70" providerId="ADAL" clId="{AF46780B-1511-4A3E-A647-F33B33846E2B}" dt="2023-08-06T03:30:35.692" v="214" actId="13926"/>
        <pc:sldMkLst>
          <pc:docMk/>
          <pc:sldMk cId="1905507674" sldId="277"/>
        </pc:sldMkLst>
        <pc:spChg chg="mod">
          <ac:chgData name="原　悠" userId="5ca70933-9236-41ae-b51f-a8548861fb70" providerId="ADAL" clId="{AF46780B-1511-4A3E-A647-F33B33846E2B}" dt="2023-08-06T03:30:35.692" v="214" actId="13926"/>
          <ac:spMkLst>
            <pc:docMk/>
            <pc:sldMk cId="1905507674" sldId="277"/>
            <ac:spMk id="9" creationId="{A9CA93BC-632A-BA83-6BC2-458BC6CEB551}"/>
          </ac:spMkLst>
        </pc:spChg>
      </pc:sldChg>
      <pc:sldChg chg="modSp mod">
        <pc:chgData name="原　悠" userId="5ca70933-9236-41ae-b51f-a8548861fb70" providerId="ADAL" clId="{AF46780B-1511-4A3E-A647-F33B33846E2B}" dt="2023-08-06T03:30:12.025" v="212" actId="13926"/>
        <pc:sldMkLst>
          <pc:docMk/>
          <pc:sldMk cId="3405513179" sldId="278"/>
        </pc:sldMkLst>
        <pc:spChg chg="mod">
          <ac:chgData name="原　悠" userId="5ca70933-9236-41ae-b51f-a8548861fb70" providerId="ADAL" clId="{AF46780B-1511-4A3E-A647-F33B33846E2B}" dt="2023-08-06T03:30:09.407" v="211" actId="13926"/>
          <ac:spMkLst>
            <pc:docMk/>
            <pc:sldMk cId="3405513179" sldId="278"/>
            <ac:spMk id="3" creationId="{DA3FD359-D048-C3A4-351F-39DEFDA7C99D}"/>
          </ac:spMkLst>
        </pc:spChg>
        <pc:graphicFrameChg chg="modGraphic">
          <ac:chgData name="原　悠" userId="5ca70933-9236-41ae-b51f-a8548861fb70" providerId="ADAL" clId="{AF46780B-1511-4A3E-A647-F33B33846E2B}" dt="2023-08-06T03:30:12.025" v="212" actId="13926"/>
          <ac:graphicFrameMkLst>
            <pc:docMk/>
            <pc:sldMk cId="3405513179" sldId="278"/>
            <ac:graphicFrameMk id="2" creationId="{091E4CBE-773D-4CA0-B1AF-D12C41AC2F0D}"/>
          </ac:graphicFrameMkLst>
        </pc:graphicFrameChg>
      </pc:sldChg>
      <pc:sldChg chg="modSp mod modNotesTx">
        <pc:chgData name="原　悠" userId="5ca70933-9236-41ae-b51f-a8548861fb70" providerId="ADAL" clId="{AF46780B-1511-4A3E-A647-F33B33846E2B}" dt="2023-08-06T00:48:17.270" v="36" actId="20577"/>
        <pc:sldMkLst>
          <pc:docMk/>
          <pc:sldMk cId="645788852" sldId="279"/>
        </pc:sldMkLst>
        <pc:spChg chg="mod">
          <ac:chgData name="原　悠" userId="5ca70933-9236-41ae-b51f-a8548861fb70" providerId="ADAL" clId="{AF46780B-1511-4A3E-A647-F33B33846E2B}" dt="2023-08-06T00:47:50.436" v="13" actId="20577"/>
          <ac:spMkLst>
            <pc:docMk/>
            <pc:sldMk cId="645788852" sldId="279"/>
            <ac:spMk id="2" creationId="{3B9278E9-7B39-A149-F398-838D5393A87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7046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2" y="1"/>
            <a:ext cx="4307046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B7F58F-AC56-4FBF-8A41-91BAC14593A1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438525" y="850900"/>
            <a:ext cx="3062288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4" y="3275965"/>
            <a:ext cx="7951470" cy="2680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65659"/>
            <a:ext cx="4307046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2" y="6465659"/>
            <a:ext cx="4307046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FC4C6-D503-4663-8862-A279B0AE57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23654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b="1" dirty="0"/>
              <a:t>Supplement figure 2.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Survival curves for 3-year IPF-related events according to CCIS and anti-fibrotic agent among 169 patients</a:t>
            </a:r>
            <a:endParaRPr kumimoji="1" lang="en-US" altLang="ja-JP" b="0" dirty="0"/>
          </a:p>
          <a:p>
            <a:r>
              <a:rPr kumimoji="1" lang="en-US" altLang="ja-JP" b="0" dirty="0"/>
              <a:t>Comparison of the </a:t>
            </a:r>
            <a:r>
              <a:rPr kumimoji="1" lang="en-US" altLang="ja-JP" dirty="0"/>
              <a:t>curves by log-rank test in 196 patients according to CCIS group (A), and according to CCIS group in patients treated with </a:t>
            </a:r>
            <a:r>
              <a:rPr kumimoji="1" lang="en-US" altLang="ja-JP" dirty="0" err="1"/>
              <a:t>nintedanib</a:t>
            </a:r>
            <a:r>
              <a:rPr kumimoji="1" lang="en-US" altLang="ja-JP" dirty="0"/>
              <a:t> (B) and pirfenidone (C) showed no significant difference (P = 0.75, P = 0.43, and P = 0.62, respectively). </a:t>
            </a:r>
            <a:endParaRPr kumimoji="1" lang="en-US" altLang="ja-JP" b="1" dirty="0"/>
          </a:p>
          <a:p>
            <a:r>
              <a:rPr kumimoji="1" lang="en-US" altLang="ja-JP" b="1" dirty="0"/>
              <a:t>Abbreviations: </a:t>
            </a:r>
            <a:r>
              <a:rPr kumimoji="1" lang="en-US" altLang="ja-JP" dirty="0"/>
              <a:t>CCIS, </a:t>
            </a:r>
            <a:r>
              <a:rPr kumimoji="1" lang="en-US" altLang="ja-JP" dirty="0" err="1"/>
              <a:t>Charlson</a:t>
            </a:r>
            <a:r>
              <a:rPr kumimoji="1" lang="en-US" altLang="ja-JP" dirty="0"/>
              <a:t> Comorbidity Index Score; IPF, idiopathic pulmonary fibrosis.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FFC4C6-D503-4663-8862-A279B0AE579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34260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375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215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2092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0743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667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100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777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7516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5233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62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100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856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A561E74-B077-0A10-2EC3-7233D28A6E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9731" y="1014402"/>
            <a:ext cx="3444538" cy="2370025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88C4628-8953-0017-1CAA-07B84A13E0C1}"/>
              </a:ext>
            </a:extLst>
          </p:cNvPr>
          <p:cNvSpPr txBox="1"/>
          <p:nvPr/>
        </p:nvSpPr>
        <p:spPr>
          <a:xfrm>
            <a:off x="3442375" y="2258912"/>
            <a:ext cx="17886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Low CCIS group (N = 117)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High CCIS group (N = 52)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P = 0.60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6F53C0A-4B3A-8BFE-83C4-FD5A76522918}"/>
              </a:ext>
            </a:extLst>
          </p:cNvPr>
          <p:cNvSpPr txBox="1"/>
          <p:nvPr/>
        </p:nvSpPr>
        <p:spPr>
          <a:xfrm rot="16200000">
            <a:off x="2388202" y="1843552"/>
            <a:ext cx="12874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Event-free rate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15DAF9B-40F5-464D-125A-458F952D83F6}"/>
              </a:ext>
            </a:extLst>
          </p:cNvPr>
          <p:cNvSpPr txBox="1"/>
          <p:nvPr/>
        </p:nvSpPr>
        <p:spPr>
          <a:xfrm>
            <a:off x="3833302" y="3106745"/>
            <a:ext cx="16987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Time to event (days)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35862CF-5BA1-4E87-C921-9C1B14224E1F}"/>
              </a:ext>
            </a:extLst>
          </p:cNvPr>
          <p:cNvSpPr txBox="1"/>
          <p:nvPr/>
        </p:nvSpPr>
        <p:spPr>
          <a:xfrm>
            <a:off x="2878015" y="645070"/>
            <a:ext cx="1523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. All patients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7B277C3-A2B8-C76D-EF95-392E1C682D32}"/>
              </a:ext>
            </a:extLst>
          </p:cNvPr>
          <p:cNvSpPr txBox="1"/>
          <p:nvPr/>
        </p:nvSpPr>
        <p:spPr>
          <a:xfrm>
            <a:off x="1661652" y="0"/>
            <a:ext cx="582069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Supplement figure 2. Survival curves for 3-year IPF-related events 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according to CCIS and anti-fibrotic agent among 169 patients</a:t>
            </a: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3718FFDE-AFEE-0B31-7309-D7E223F346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4176" y="3967047"/>
            <a:ext cx="3444538" cy="2370025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70D5EDB-D916-D423-EC1C-C09F999CE807}"/>
              </a:ext>
            </a:extLst>
          </p:cNvPr>
          <p:cNvSpPr txBox="1"/>
          <p:nvPr/>
        </p:nvSpPr>
        <p:spPr>
          <a:xfrm>
            <a:off x="1077213" y="5220221"/>
            <a:ext cx="17393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Low CCIS group (N = 59)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High CCIS group (N = 28)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P = 0.17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869C11B-B404-82BA-2190-289D47FA9AA7}"/>
              </a:ext>
            </a:extLst>
          </p:cNvPr>
          <p:cNvSpPr txBox="1"/>
          <p:nvPr/>
        </p:nvSpPr>
        <p:spPr>
          <a:xfrm rot="16200000">
            <a:off x="12647" y="4796198"/>
            <a:ext cx="12874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Event-free rate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370331F-BF49-44E7-2709-FBDD585C95DE}"/>
              </a:ext>
            </a:extLst>
          </p:cNvPr>
          <p:cNvSpPr txBox="1"/>
          <p:nvPr/>
        </p:nvSpPr>
        <p:spPr>
          <a:xfrm>
            <a:off x="1457747" y="6059391"/>
            <a:ext cx="16987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Time to event (days)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4F955F4-56A8-6561-F700-BA9CB2335016}"/>
              </a:ext>
            </a:extLst>
          </p:cNvPr>
          <p:cNvSpPr txBox="1"/>
          <p:nvPr/>
        </p:nvSpPr>
        <p:spPr>
          <a:xfrm>
            <a:off x="474176" y="3581955"/>
            <a:ext cx="2102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B. </a:t>
            </a: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Nintedanib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group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89D4CC67-5830-BF38-A170-67E879E4E2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25286" y="3967046"/>
            <a:ext cx="3444538" cy="2370025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0085EC3-3148-6CFF-1B72-8C586546624C}"/>
              </a:ext>
            </a:extLst>
          </p:cNvPr>
          <p:cNvSpPr txBox="1"/>
          <p:nvPr/>
        </p:nvSpPr>
        <p:spPr>
          <a:xfrm>
            <a:off x="5832963" y="5208277"/>
            <a:ext cx="17454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Low CCIS group (N = 58)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High CCIS group (N = 24)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P = 0.51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FFDFF10-C0FB-C438-B3AC-07D3CA4752AB}"/>
              </a:ext>
            </a:extLst>
          </p:cNvPr>
          <p:cNvSpPr txBox="1"/>
          <p:nvPr/>
        </p:nvSpPr>
        <p:spPr>
          <a:xfrm rot="16200000">
            <a:off x="4763755" y="4796198"/>
            <a:ext cx="12874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Event-free rate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0D2C5C5-8E00-BEC5-0B3F-2FBCE50E2095}"/>
              </a:ext>
            </a:extLst>
          </p:cNvPr>
          <p:cNvSpPr txBox="1"/>
          <p:nvPr/>
        </p:nvSpPr>
        <p:spPr>
          <a:xfrm>
            <a:off x="6208855" y="6059391"/>
            <a:ext cx="16987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Time to event (days)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A6AFF60-C5B2-FE55-EDD6-438F28FA6F06}"/>
              </a:ext>
            </a:extLst>
          </p:cNvPr>
          <p:cNvSpPr txBox="1"/>
          <p:nvPr/>
        </p:nvSpPr>
        <p:spPr>
          <a:xfrm>
            <a:off x="5220657" y="3581955"/>
            <a:ext cx="21430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C. Pirfenidone group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52763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6</TotalTime>
  <Words>202</Words>
  <Application>Microsoft Office PowerPoint</Application>
  <PresentationFormat>画面に合わせる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原　悠</dc:creator>
  <cp:lastModifiedBy>原　悠</cp:lastModifiedBy>
  <cp:revision>9</cp:revision>
  <cp:lastPrinted>2023-03-25T22:56:31Z</cp:lastPrinted>
  <dcterms:created xsi:type="dcterms:W3CDTF">2022-10-17T23:58:32Z</dcterms:created>
  <dcterms:modified xsi:type="dcterms:W3CDTF">2023-08-06T06:07:40Z</dcterms:modified>
</cp:coreProperties>
</file>